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9" autoAdjust="0"/>
    <p:restoredTop sz="94660"/>
  </p:normalViewPr>
  <p:slideViewPr>
    <p:cSldViewPr snapToGrid="0">
      <p:cViewPr varScale="1">
        <p:scale>
          <a:sx n="62" d="100"/>
          <a:sy n="62" d="100"/>
        </p:scale>
        <p:origin x="1884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5F8F47-A9D5-4CDB-9A4C-A1CA9CA5A76A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7E013D-873D-4537-9A4F-092013F4F7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585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16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236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20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163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627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862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85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669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214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594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664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BD7F7-736F-4636-B77D-1E05ADA6E256}" type="datetimeFigureOut">
              <a:rPr lang="en-GB" smtClean="0"/>
              <a:t>2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99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E51056E-8E91-4D06-846A-445404B67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71" y="1450544"/>
            <a:ext cx="6748857" cy="700491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C84C828-E3F4-48FC-9F5A-1B2BAE8DE5BA}"/>
              </a:ext>
            </a:extLst>
          </p:cNvPr>
          <p:cNvSpPr txBox="1"/>
          <p:nvPr/>
        </p:nvSpPr>
        <p:spPr>
          <a:xfrm>
            <a:off x="435429" y="8621486"/>
            <a:ext cx="59989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igure S4. No-antibody control  images for immunolabelling of grain sections of control and triple stack lines.</a:t>
            </a:r>
          </a:p>
        </p:txBody>
      </p:sp>
    </p:spTree>
    <p:extLst>
      <p:ext uri="{BB962C8B-B14F-4D97-AF65-F5344CB8AC3E}">
        <p14:creationId xmlns:p14="http://schemas.microsoft.com/office/powerpoint/2010/main" val="1483420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14</TotalTime>
  <Words>18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wan Mitchell</dc:creator>
  <cp:lastModifiedBy>Rowan Mitchell</cp:lastModifiedBy>
  <cp:revision>105</cp:revision>
  <dcterms:created xsi:type="dcterms:W3CDTF">2018-11-08T10:54:33Z</dcterms:created>
  <dcterms:modified xsi:type="dcterms:W3CDTF">2020-04-27T09:45:07Z</dcterms:modified>
</cp:coreProperties>
</file>